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362806" y="-12148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400" b="1" kern="100" dirty="0">
                <a:solidFill>
                  <a:schemeClr val="bg1"/>
                </a:solidFill>
                <a:effectLst/>
                <a:latin typeface="+mn-lt"/>
                <a:ea typeface="Aptos" panose="020B0004020202020204" pitchFamily="34" charset="0"/>
                <a:cs typeface="Aptos" panose="020B0004020202020204" pitchFamily="34" charset="0"/>
              </a:rPr>
              <a:t>Therapeutic strategies for hypertension: exploring the role of microbiota-derived short-chain fatty acids in kidney physiology and development</a:t>
            </a:r>
            <a:endParaRPr lang="en-US" sz="2400" kern="100" dirty="0">
              <a:solidFill>
                <a:schemeClr val="bg1"/>
              </a:solidFill>
              <a:effectLst/>
              <a:latin typeface="+mn-lt"/>
              <a:ea typeface="Aptos" panose="020B0004020202020204" pitchFamily="34" charset="0"/>
              <a:cs typeface="Aptos" panose="020B00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175528" y="1131206"/>
            <a:ext cx="6170481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Key points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hort-chain fatty acids (SCFAs) produced by the gut microbiota play a key role in modulating kidney function</a:t>
            </a:r>
            <a:r>
              <a:rPr lang="en-US" sz="18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CFAs regulate blood pressure through interactions with specific G protein-coupled receptors.  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.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Gut microbiota-derived SCFAs contribute to maintaining renal epithelial integrity and reducing inflammation.</a:t>
            </a:r>
          </a:p>
          <a:p>
            <a:endParaRPr lang="en-US" dirty="0"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r>
              <a:rPr lang="en-US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4.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CFAs impact renin release and arterial tone, resulting in the maintenance of proper blood pressure control.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CFA signaling presents a promising avenue for novel therapeutic strategies targeting hypertension.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rtelote 2025</a:t>
            </a:r>
            <a:endParaRPr lang="en-GB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2400" b="1" dirty="0">
                <a:solidFill>
                  <a:schemeClr val="bg1"/>
                </a:solidFill>
                <a:cs typeface="Arial" panose="020B0604020202020204" pitchFamily="34" charset="0"/>
              </a:rPr>
              <a:t>TAKE HOME MESSAGE</a:t>
            </a:r>
            <a:r>
              <a:rPr lang="en-GB" sz="2400" dirty="0">
                <a:solidFill>
                  <a:schemeClr val="bg1"/>
                </a:solidFill>
                <a:cs typeface="Arial" panose="020B0604020202020204" pitchFamily="34" charset="0"/>
              </a:rPr>
              <a:t>: Microbiota-derived SCFAs are pivotal for kidney development and proper blood pressure control.</a:t>
            </a:r>
          </a:p>
        </p:txBody>
      </p:sp>
      <p:pic>
        <p:nvPicPr>
          <p:cNvPr id="9" name="Picture 8" descr="Diagram of a diagram showing blood pressure and blood pressure&#10;&#10;AI-generated content may be incorrect.">
            <a:extLst>
              <a:ext uri="{FF2B5EF4-FFF2-40B4-BE49-F238E27FC236}">
                <a16:creationId xmlns:a16="http://schemas.microsoft.com/office/drawing/2014/main" id="{13AAF569-66A3-B238-1D10-928DB604DC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6009" y="1393789"/>
            <a:ext cx="5771149" cy="40398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8</TotalTime>
  <Words>126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9</cp:revision>
  <dcterms:created xsi:type="dcterms:W3CDTF">2019-06-13T12:30:18Z</dcterms:created>
  <dcterms:modified xsi:type="dcterms:W3CDTF">2025-06-23T22:37:54Z</dcterms:modified>
</cp:coreProperties>
</file>